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 showGuides="1">
      <p:cViewPr>
        <p:scale>
          <a:sx n="108" d="100"/>
          <a:sy n="108" d="100"/>
        </p:scale>
        <p:origin x="2976" y="-2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510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657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642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750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002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794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58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047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692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731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483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4BEF0-92AF-9445-9B41-1CAAD3776EF3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A824B-2865-5D4A-AC92-8BB033AE7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654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1427E812-65DB-4740-8094-AD18F62361CD}"/>
              </a:ext>
            </a:extLst>
          </p:cNvPr>
          <p:cNvGrpSpPr/>
          <p:nvPr/>
        </p:nvGrpSpPr>
        <p:grpSpPr>
          <a:xfrm>
            <a:off x="583882" y="2553731"/>
            <a:ext cx="5690234" cy="7002386"/>
            <a:chOff x="0" y="-82158"/>
            <a:chExt cx="5690656" cy="7002695"/>
          </a:xfrm>
        </p:grpSpPr>
        <p:sp>
          <p:nvSpPr>
            <p:cNvPr id="13" name="Text Box 25">
              <a:extLst>
                <a:ext uri="{FF2B5EF4-FFF2-40B4-BE49-F238E27FC236}">
                  <a16:creationId xmlns:a16="http://schemas.microsoft.com/office/drawing/2014/main" id="{7C07A9BB-A190-5641-8A4C-0AAB8D927F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24000" y="5897880"/>
              <a:ext cx="4166656" cy="1022657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13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Paired CT &amp; CMR images from 96 patients were analysed</a:t>
              </a:r>
              <a:endPara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  <a:p>
              <a:pPr marL="914400" indent="-228600" eaLnBrk="0" fontAlgn="base" hangingPunct="0">
                <a:spcAft>
                  <a:spcPts val="0"/>
                </a:spcAft>
                <a:tabLst>
                  <a:tab pos="914400" algn="l"/>
                </a:tabLst>
              </a:pPr>
              <a:r>
                <a:rPr lang="en-US" sz="13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ViKTORIES trial: 72 patients</a:t>
              </a:r>
              <a:endPara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  <a:p>
              <a:pPr marL="914400" indent="-228600" eaLnBrk="0" fontAlgn="base" hangingPunct="0">
                <a:spcAft>
                  <a:spcPts val="0"/>
                </a:spcAft>
                <a:tabLst>
                  <a:tab pos="914400" algn="l"/>
                </a:tabLst>
              </a:pPr>
              <a:r>
                <a:rPr lang="en-US" sz="13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TICKER trial: 24 patients </a:t>
              </a:r>
              <a:endPara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0B8DC139-FCC1-AD47-B890-B0CB2F8E90E3}"/>
                </a:ext>
              </a:extLst>
            </p:cNvPr>
            <p:cNvGrpSpPr/>
            <p:nvPr/>
          </p:nvGrpSpPr>
          <p:grpSpPr>
            <a:xfrm>
              <a:off x="0" y="-82158"/>
              <a:ext cx="5617734" cy="5972451"/>
              <a:chOff x="0" y="-82158"/>
              <a:chExt cx="5617734" cy="5972451"/>
            </a:xfrm>
          </p:grpSpPr>
          <p:sp>
            <p:nvSpPr>
              <p:cNvPr id="15" name="Text Box 24">
                <a:extLst>
                  <a:ext uri="{FF2B5EF4-FFF2-40B4-BE49-F238E27FC236}">
                    <a16:creationId xmlns:a16="http://schemas.microsoft.com/office/drawing/2014/main" id="{4F2D527C-CD44-5341-AE57-B9291FF9396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452282" y="-82158"/>
                <a:ext cx="4165452" cy="884330"/>
              </a:xfrm>
              <a:prstGeom prst="rect">
                <a:avLst/>
              </a:prstGeom>
              <a:solidFill>
                <a:srgbClr val="FFFFFF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just" eaLnBrk="0" fontAlgn="base" hangingPunct="0">
                  <a:spcAft>
                    <a:spcPts val="0"/>
                  </a:spcAft>
                </a:pPr>
                <a:r>
                  <a:rPr lang="en-US" sz="135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CT and/or CMR images were obtained from 108 patients.   </a:t>
                </a:r>
                <a:endParaRPr lang="en-GB" sz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endParaRPr>
              </a:p>
              <a:p>
                <a:pPr marL="457200" indent="-228600" algn="just" eaLnBrk="0" fontAlgn="base" hangingPunct="0">
                  <a:spcAft>
                    <a:spcPts val="0"/>
                  </a:spcAft>
                  <a:tabLst>
                    <a:tab pos="457200" algn="l"/>
                  </a:tabLst>
                </a:pPr>
                <a:r>
                  <a:rPr lang="en-US" sz="135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ViKTORIES trial: 83 patients</a:t>
                </a:r>
                <a:endParaRPr lang="en-GB" sz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endParaRPr>
              </a:p>
              <a:p>
                <a:pPr marL="457200" indent="-228600" algn="just" eaLnBrk="0" fontAlgn="base" hangingPunct="0">
                  <a:spcAft>
                    <a:spcPts val="0"/>
                  </a:spcAft>
                  <a:tabLst>
                    <a:tab pos="457200" algn="l"/>
                  </a:tabLst>
                </a:pPr>
                <a:r>
                  <a:rPr lang="en-US" sz="135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TICKER trial: 25 patients</a:t>
                </a:r>
                <a:endParaRPr lang="en-GB" sz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6" name="TextBox 1">
                <a:extLst>
                  <a:ext uri="{FF2B5EF4-FFF2-40B4-BE49-F238E27FC236}">
                    <a16:creationId xmlns:a16="http://schemas.microsoft.com/office/drawing/2014/main" id="{213CDB5E-E365-C345-B6EB-B982F6E58FA3}"/>
                  </a:ext>
                </a:extLst>
              </p:cNvPr>
              <p:cNvSpPr txBox="1"/>
              <p:nvPr/>
            </p:nvSpPr>
            <p:spPr>
              <a:xfrm>
                <a:off x="1734671" y="1425389"/>
                <a:ext cx="1583690" cy="45902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2000" b="1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xcluded</a:t>
                </a:r>
                <a:endParaRPr lang="en-GB" sz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endParaRPr>
              </a:p>
            </p:txBody>
          </p: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06E985D6-CCFF-D540-9082-728CDC9B9A9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492624" y="1842247"/>
                <a:ext cx="2074768" cy="782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0">
                <a:extLst>
                  <a:ext uri="{FF2B5EF4-FFF2-40B4-BE49-F238E27FC236}">
                    <a16:creationId xmlns:a16="http://schemas.microsoft.com/office/drawing/2014/main" id="{49312822-9DE5-114B-9F0A-4754954AA58B}"/>
                  </a:ext>
                </a:extLst>
              </p:cNvPr>
              <p:cNvSpPr txBox="1"/>
              <p:nvPr/>
            </p:nvSpPr>
            <p:spPr>
              <a:xfrm>
                <a:off x="3523129" y="4612342"/>
                <a:ext cx="1583690" cy="45902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2000" b="1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Included</a:t>
                </a:r>
                <a:endParaRPr lang="en-GB" sz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9" name="Text Box 26">
                <a:extLst>
                  <a:ext uri="{FF2B5EF4-FFF2-40B4-BE49-F238E27FC236}">
                    <a16:creationId xmlns:a16="http://schemas.microsoft.com/office/drawing/2014/main" id="{FAF5B8A8-B6C3-3844-ADF5-C55B7E998C1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0" y="2245659"/>
                <a:ext cx="3168203" cy="1896928"/>
              </a:xfrm>
              <a:prstGeom prst="rect">
                <a:avLst/>
              </a:prstGeom>
              <a:solidFill>
                <a:srgbClr val="FFFFFF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noAutofit/>
              </a:bodyPr>
              <a:lstStyle/>
              <a:p>
                <a:pPr eaLnBrk="0" fontAlgn="base" hangingPunct="0">
                  <a:spcAft>
                    <a:spcPts val="0"/>
                  </a:spcAft>
                </a:pPr>
                <a:r>
                  <a:rPr lang="en-US" sz="135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12 patients were excluded from analysis</a:t>
                </a:r>
                <a:endParaRPr lang="en-GB" sz="135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endParaRPr>
              </a:p>
              <a:p>
                <a:pPr marL="742950" lvl="1" indent="-285750" eaLnBrk="0" fontAlgn="base" hangingPunct="0">
                  <a:spcAft>
                    <a:spcPts val="0"/>
                  </a:spcAft>
                  <a:buFont typeface="Times New Roman" panose="02020603050405020304" pitchFamily="18" charset="0"/>
                  <a:buChar char="•"/>
                  <a:tabLst>
                    <a:tab pos="914400" algn="l"/>
                  </a:tabLst>
                </a:pPr>
                <a:r>
                  <a:rPr lang="en-US" sz="135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ViKTORIES trial: 11 patients</a:t>
                </a:r>
                <a:endParaRPr lang="en-GB" sz="135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endParaRPr>
              </a:p>
              <a:p>
                <a:pPr marL="742950" lvl="1" indent="-285750" eaLnBrk="0" fontAlgn="base" hangingPunct="0">
                  <a:spcAft>
                    <a:spcPts val="0"/>
                  </a:spcAft>
                  <a:buFont typeface="Times New Roman" panose="02020603050405020304" pitchFamily="18" charset="0"/>
                  <a:buChar char="•"/>
                  <a:tabLst>
                    <a:tab pos="914400" algn="l"/>
                  </a:tabLst>
                </a:pPr>
                <a:r>
                  <a:rPr lang="en-US" sz="135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TICKER trial: 1 patient</a:t>
                </a:r>
                <a:endParaRPr lang="en-GB" sz="135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endParaRPr>
              </a:p>
              <a:p>
                <a:pPr eaLnBrk="0" fontAlgn="base" hangingPunct="0">
                  <a:spcAft>
                    <a:spcPts val="0"/>
                  </a:spcAft>
                </a:pPr>
                <a:r>
                  <a:rPr lang="en-US" sz="135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easons:</a:t>
                </a:r>
                <a:endParaRPr lang="en-GB" sz="135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marL="742950" lvl="1" indent="-285750" eaLnBrk="0" fontAlgn="base" hangingPunct="0">
                  <a:spcAft>
                    <a:spcPts val="0"/>
                  </a:spcAft>
                  <a:buFont typeface="Arial" panose="020B0604020202020204" pitchFamily="34" charset="0"/>
                  <a:buChar char="•"/>
                  <a:tabLst>
                    <a:tab pos="914400" algn="l"/>
                  </a:tabLst>
                </a:pPr>
                <a:r>
                  <a:rPr lang="en-US" sz="135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orta out of view: 6 patients</a:t>
                </a:r>
                <a:endParaRPr lang="en-GB" sz="135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marL="742950" lvl="1" indent="-285750" eaLnBrk="0" fontAlgn="base" hangingPunct="0">
                  <a:spcAft>
                    <a:spcPts val="0"/>
                  </a:spcAft>
                  <a:buFont typeface="Arial" panose="020B0604020202020204" pitchFamily="34" charset="0"/>
                  <a:buChar char="•"/>
                  <a:tabLst>
                    <a:tab pos="914400" algn="l"/>
                  </a:tabLst>
                </a:pPr>
                <a:r>
                  <a:rPr lang="en-US" sz="135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ssing paired CMR images: 6 patients </a:t>
                </a:r>
              </a:p>
            </p:txBody>
          </p: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BF77BCD3-6250-E847-B97F-73F60E54E5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88888" y="1828800"/>
                <a:ext cx="0" cy="40583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Arrow Connector 20">
                <a:extLst>
                  <a:ext uri="{FF2B5EF4-FFF2-40B4-BE49-F238E27FC236}">
                    <a16:creationId xmlns:a16="http://schemas.microsoft.com/office/drawing/2014/main" id="{CA4A042C-3352-A940-A6CD-D644ED511A6A}"/>
                  </a:ext>
                </a:extLst>
              </p:cNvPr>
              <p:cNvCxnSpPr/>
              <p:nvPr/>
            </p:nvCxnSpPr>
            <p:spPr>
              <a:xfrm>
                <a:off x="3559735" y="820271"/>
                <a:ext cx="0" cy="507002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529068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76</Words>
  <Application>Microsoft Macintosh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bert Edy (student)</dc:creator>
  <cp:lastModifiedBy>Elbert Edy (student)</cp:lastModifiedBy>
  <cp:revision>5</cp:revision>
  <dcterms:created xsi:type="dcterms:W3CDTF">2020-06-10T16:53:15Z</dcterms:created>
  <dcterms:modified xsi:type="dcterms:W3CDTF">2020-09-11T19:43:07Z</dcterms:modified>
</cp:coreProperties>
</file>